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7561263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18" autoAdjust="0"/>
    <p:restoredTop sz="94660"/>
  </p:normalViewPr>
  <p:slideViewPr>
    <p:cSldViewPr snapToGrid="0">
      <p:cViewPr>
        <p:scale>
          <a:sx n="98" d="100"/>
          <a:sy n="98" d="100"/>
        </p:scale>
        <p:origin x="658" y="-438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PHOTO\OneDrive\Desktop\PgMADS%20gene%20network\network%20for%2095%20genes%20ex.%20in%20tissues\95%20PgMADS%20in%2014%20tissu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PHOTO\OneDrive\Desktop\PgMADS%20gene%20network\network%20for%2095%20genes%20ex.%20in%20tissues\95%20PgMADS%20in%2014%20tissu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PHOTO\OneDrive\Desktop\PgMADS%20gene%20network\network%20for%2085%20genes%20exp.%20in%20genotypes\MADS42%20graph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PHOTO\OneDrive\Desktop\PgMADS%20gene%20network\network%20for%2085%20genes%20exp.%20in%20genotypes\MADS42%20graph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39:$B$40</c:f>
              <c:strCache>
                <c:ptCount val="2"/>
                <c:pt idx="1">
                  <c:v>95 PgMADS gene transcript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s!$D$41:$D$45</c:f>
                <c:numCache>
                  <c:formatCode>General</c:formatCode>
                  <c:ptCount val="5"/>
                  <c:pt idx="0">
                    <c:v>0.84983658559879749</c:v>
                  </c:pt>
                  <c:pt idx="1">
                    <c:v>2.7100635498903793</c:v>
                  </c:pt>
                  <c:pt idx="2">
                    <c:v>3.8715486421958962</c:v>
                  </c:pt>
                  <c:pt idx="3">
                    <c:v>3.3082388735465345</c:v>
                  </c:pt>
                  <c:pt idx="4">
                    <c:v>4.7853944456021598</c:v>
                  </c:pt>
                </c:numCache>
              </c:numRef>
            </c:plus>
            <c:minus>
              <c:numRef>
                <c:f>graphs!$D$41:$D$45</c:f>
                <c:numCache>
                  <c:formatCode>General</c:formatCode>
                  <c:ptCount val="5"/>
                  <c:pt idx="0">
                    <c:v>0.84983658559879749</c:v>
                  </c:pt>
                  <c:pt idx="1">
                    <c:v>2.7100635498903793</c:v>
                  </c:pt>
                  <c:pt idx="2">
                    <c:v>3.8715486421958962</c:v>
                  </c:pt>
                  <c:pt idx="3">
                    <c:v>3.3082388735465345</c:v>
                  </c:pt>
                  <c:pt idx="4">
                    <c:v>4.78539444560215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aphs!$A$41:$A$45</c:f>
              <c:strCache>
                <c:ptCount val="5"/>
                <c:pt idx="0">
                  <c:v>5.0-E02</c:v>
                </c:pt>
                <c:pt idx="1">
                  <c:v>1.0-E02</c:v>
                </c:pt>
                <c:pt idx="2">
                  <c:v>1.0-E03</c:v>
                </c:pt>
                <c:pt idx="3">
                  <c:v>1.0-E04</c:v>
                </c:pt>
                <c:pt idx="4">
                  <c:v>1.0-E05</c:v>
                </c:pt>
              </c:strCache>
            </c:strRef>
          </c:cat>
          <c:val>
            <c:numRef>
              <c:f>graphs!$B$41:$B$45</c:f>
              <c:numCache>
                <c:formatCode>General</c:formatCode>
                <c:ptCount val="5"/>
                <c:pt idx="0">
                  <c:v>94.5</c:v>
                </c:pt>
                <c:pt idx="1">
                  <c:v>88.3</c:v>
                </c:pt>
                <c:pt idx="2">
                  <c:v>69.900000000000006</c:v>
                </c:pt>
                <c:pt idx="3">
                  <c:v>56.5</c:v>
                </c:pt>
                <c:pt idx="4">
                  <c:v>46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CF-4CB9-9DE1-4868A10637F3}"/>
            </c:ext>
          </c:extLst>
        </c:ser>
        <c:ser>
          <c:idx val="1"/>
          <c:order val="1"/>
          <c:tx>
            <c:strRef>
              <c:f>graphs!$C$39:$C$40</c:f>
              <c:strCache>
                <c:ptCount val="2"/>
                <c:pt idx="1">
                  <c:v>95 Unknown randomly selected  ginseng gen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s!$E$41:$E$45</c:f>
                <c:numCache>
                  <c:formatCode>General</c:formatCode>
                  <c:ptCount val="5"/>
                  <c:pt idx="0">
                    <c:v>0.84327404271156781</c:v>
                  </c:pt>
                  <c:pt idx="1">
                    <c:v>4.9988887654046561</c:v>
                  </c:pt>
                  <c:pt idx="2">
                    <c:v>3.1989581637360209</c:v>
                  </c:pt>
                  <c:pt idx="3">
                    <c:v>2.8751811537130432</c:v>
                  </c:pt>
                  <c:pt idx="4">
                    <c:v>2.7487370837451071</c:v>
                  </c:pt>
                </c:numCache>
              </c:numRef>
            </c:plus>
            <c:minus>
              <c:numRef>
                <c:f>graphs!$E$41:$E$45</c:f>
                <c:numCache>
                  <c:formatCode>General</c:formatCode>
                  <c:ptCount val="5"/>
                  <c:pt idx="0">
                    <c:v>0.84327404271156781</c:v>
                  </c:pt>
                  <c:pt idx="1">
                    <c:v>4.9988887654046561</c:v>
                  </c:pt>
                  <c:pt idx="2">
                    <c:v>3.1989581637360209</c:v>
                  </c:pt>
                  <c:pt idx="3">
                    <c:v>2.8751811537130432</c:v>
                  </c:pt>
                  <c:pt idx="4">
                    <c:v>2.74873708374510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aphs!$A$41:$A$45</c:f>
              <c:strCache>
                <c:ptCount val="5"/>
                <c:pt idx="0">
                  <c:v>5.0-E02</c:v>
                </c:pt>
                <c:pt idx="1">
                  <c:v>1.0-E02</c:v>
                </c:pt>
                <c:pt idx="2">
                  <c:v>1.0-E03</c:v>
                </c:pt>
                <c:pt idx="3">
                  <c:v>1.0-E04</c:v>
                </c:pt>
                <c:pt idx="4">
                  <c:v>1.0-E05</c:v>
                </c:pt>
              </c:strCache>
            </c:strRef>
          </c:cat>
          <c:val>
            <c:numRef>
              <c:f>graphs!$C$41:$C$45</c:f>
              <c:numCache>
                <c:formatCode>General</c:formatCode>
                <c:ptCount val="5"/>
                <c:pt idx="0">
                  <c:v>93.6</c:v>
                </c:pt>
                <c:pt idx="1">
                  <c:v>77.900000000000006</c:v>
                </c:pt>
                <c:pt idx="2">
                  <c:v>49.3</c:v>
                </c:pt>
                <c:pt idx="3">
                  <c:v>34.4</c:v>
                </c:pt>
                <c:pt idx="4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FCF-4CB9-9DE1-4868A10637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1690753407"/>
        <c:axId val="1690755327"/>
      </c:barChart>
      <c:catAx>
        <c:axId val="169075340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i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001" i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lue used for network construc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90755327"/>
        <c:crosses val="autoZero"/>
        <c:auto val="1"/>
        <c:lblAlgn val="ctr"/>
        <c:lblOffset val="100"/>
        <c:noMultiLvlLbl val="0"/>
      </c:catAx>
      <c:valAx>
        <c:axId val="1690755327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00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nodes</a:t>
                </a:r>
                <a:endParaRPr lang="en-ZA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9075340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5.0663385826771663E-2"/>
          <c:y val="2.7777777777777776E-2"/>
          <c:w val="0.92922878390201225"/>
          <c:h val="0.149306649168853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54:$B$55</c:f>
              <c:strCache>
                <c:ptCount val="2"/>
                <c:pt idx="1">
                  <c:v>95 PgMADS gene transcript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s!$D$56:$D$60</c:f>
                <c:numCache>
                  <c:formatCode>General</c:formatCode>
                  <c:ptCount val="5"/>
                  <c:pt idx="0">
                    <c:v>31.312226933828192</c:v>
                  </c:pt>
                  <c:pt idx="1">
                    <c:v>24.791575630084957</c:v>
                  </c:pt>
                  <c:pt idx="2">
                    <c:v>30.807827288243157</c:v>
                  </c:pt>
                  <c:pt idx="3">
                    <c:v>27.11293254355034</c:v>
                  </c:pt>
                  <c:pt idx="4">
                    <c:v>32.356520895245282</c:v>
                  </c:pt>
                </c:numCache>
              </c:numRef>
            </c:plus>
            <c:minus>
              <c:numRef>
                <c:f>graphs!$D$56:$D$60</c:f>
                <c:numCache>
                  <c:formatCode>General</c:formatCode>
                  <c:ptCount val="5"/>
                  <c:pt idx="0">
                    <c:v>31.312226933828192</c:v>
                  </c:pt>
                  <c:pt idx="1">
                    <c:v>24.791575630084957</c:v>
                  </c:pt>
                  <c:pt idx="2">
                    <c:v>30.807827288243157</c:v>
                  </c:pt>
                  <c:pt idx="3">
                    <c:v>27.11293254355034</c:v>
                  </c:pt>
                  <c:pt idx="4">
                    <c:v>32.3565208952452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aphs!$A$56:$A$60</c:f>
              <c:strCache>
                <c:ptCount val="5"/>
                <c:pt idx="0">
                  <c:v>5.0-E02</c:v>
                </c:pt>
                <c:pt idx="1">
                  <c:v>1.0-E02</c:v>
                </c:pt>
                <c:pt idx="2">
                  <c:v>1.0-E03</c:v>
                </c:pt>
                <c:pt idx="3">
                  <c:v>1.0-E04</c:v>
                </c:pt>
                <c:pt idx="4">
                  <c:v>1.0-E05</c:v>
                </c:pt>
              </c:strCache>
            </c:strRef>
          </c:cat>
          <c:val>
            <c:numRef>
              <c:f>graphs!$B$56:$B$60</c:f>
              <c:numCache>
                <c:formatCode>General</c:formatCode>
                <c:ptCount val="5"/>
                <c:pt idx="0">
                  <c:v>549.70000000000005</c:v>
                </c:pt>
                <c:pt idx="1">
                  <c:v>353.2</c:v>
                </c:pt>
                <c:pt idx="2">
                  <c:v>223.7</c:v>
                </c:pt>
                <c:pt idx="3">
                  <c:v>169</c:v>
                </c:pt>
                <c:pt idx="4">
                  <c:v>143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9D-418E-AC2A-BDDC629348D4}"/>
            </c:ext>
          </c:extLst>
        </c:ser>
        <c:ser>
          <c:idx val="1"/>
          <c:order val="1"/>
          <c:tx>
            <c:strRef>
              <c:f>graphs!$C$54:$C$55</c:f>
              <c:strCache>
                <c:ptCount val="2"/>
                <c:pt idx="1">
                  <c:v>95 Unknown randomly selected  ginseng gen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s!$E$56:$E$60</c:f>
                <c:numCache>
                  <c:formatCode>General</c:formatCode>
                  <c:ptCount val="5"/>
                  <c:pt idx="0">
                    <c:v>45.711778205038982</c:v>
                  </c:pt>
                  <c:pt idx="1">
                    <c:v>26.6301833765122</c:v>
                  </c:pt>
                  <c:pt idx="2">
                    <c:v>16.049922118191102</c:v>
                  </c:pt>
                  <c:pt idx="3">
                    <c:v>22.306202425932284</c:v>
                  </c:pt>
                  <c:pt idx="4">
                    <c:v>16.900032873077823</c:v>
                  </c:pt>
                </c:numCache>
              </c:numRef>
            </c:plus>
            <c:minus>
              <c:numRef>
                <c:f>graphs!$E$56:$E$60</c:f>
                <c:numCache>
                  <c:formatCode>General</c:formatCode>
                  <c:ptCount val="5"/>
                  <c:pt idx="0">
                    <c:v>45.711778205038982</c:v>
                  </c:pt>
                  <c:pt idx="1">
                    <c:v>26.6301833765122</c:v>
                  </c:pt>
                  <c:pt idx="2">
                    <c:v>16.049922118191102</c:v>
                  </c:pt>
                  <c:pt idx="3">
                    <c:v>22.306202425932284</c:v>
                  </c:pt>
                  <c:pt idx="4">
                    <c:v>16.9000328730778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aphs!$A$56:$A$60</c:f>
              <c:strCache>
                <c:ptCount val="5"/>
                <c:pt idx="0">
                  <c:v>5.0-E02</c:v>
                </c:pt>
                <c:pt idx="1">
                  <c:v>1.0-E02</c:v>
                </c:pt>
                <c:pt idx="2">
                  <c:v>1.0-E03</c:v>
                </c:pt>
                <c:pt idx="3">
                  <c:v>1.0-E04</c:v>
                </c:pt>
                <c:pt idx="4">
                  <c:v>1.0-E05</c:v>
                </c:pt>
              </c:strCache>
            </c:strRef>
          </c:cat>
          <c:val>
            <c:numRef>
              <c:f>graphs!$C$56:$C$60</c:f>
              <c:numCache>
                <c:formatCode>General</c:formatCode>
                <c:ptCount val="5"/>
                <c:pt idx="0">
                  <c:v>404.7</c:v>
                </c:pt>
                <c:pt idx="1">
                  <c:v>252.5</c:v>
                </c:pt>
                <c:pt idx="2">
                  <c:v>167.6</c:v>
                </c:pt>
                <c:pt idx="3">
                  <c:v>144.69999999999999</c:v>
                </c:pt>
                <c:pt idx="4">
                  <c:v>127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99D-418E-AC2A-BDDC629348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1528775903"/>
        <c:axId val="1528776863"/>
      </c:barChart>
      <c:catAx>
        <c:axId val="152877590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i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001" i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lues used for construc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8776863"/>
        <c:crosses val="autoZero"/>
        <c:auto val="1"/>
        <c:lblAlgn val="ctr"/>
        <c:lblOffset val="100"/>
        <c:noMultiLvlLbl val="0"/>
      </c:catAx>
      <c:valAx>
        <c:axId val="1528776863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Number of edg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877590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MADS14!$B$33</c:f>
              <c:strCache>
                <c:ptCount val="1"/>
                <c:pt idx="0">
                  <c:v>139 PgMADS gene transcripts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MADS14!$A$34:$A$38</c:f>
              <c:strCache>
                <c:ptCount val="5"/>
                <c:pt idx="0">
                  <c:v>5.0-E02</c:v>
                </c:pt>
                <c:pt idx="1">
                  <c:v>1.0-E02</c:v>
                </c:pt>
                <c:pt idx="2">
                  <c:v>1.0-E03</c:v>
                </c:pt>
                <c:pt idx="3">
                  <c:v>1.0-E04</c:v>
                </c:pt>
                <c:pt idx="4">
                  <c:v>1.0-E05</c:v>
                </c:pt>
              </c:strCache>
              <c:extLst/>
            </c:strRef>
          </c:cat>
          <c:val>
            <c:numRef>
              <c:f>MADS14!$B$34:$B$38</c:f>
              <c:numCache>
                <c:formatCode>General</c:formatCode>
                <c:ptCount val="5"/>
                <c:pt idx="0">
                  <c:v>139</c:v>
                </c:pt>
                <c:pt idx="1">
                  <c:v>132</c:v>
                </c:pt>
                <c:pt idx="2">
                  <c:v>111</c:v>
                </c:pt>
                <c:pt idx="3">
                  <c:v>90</c:v>
                </c:pt>
                <c:pt idx="4">
                  <c:v>75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0-15A8-45F4-8CB0-96A6E5465012}"/>
            </c:ext>
          </c:extLst>
        </c:ser>
        <c:ser>
          <c:idx val="1"/>
          <c:order val="1"/>
          <c:tx>
            <c:strRef>
              <c:f>MADS14!$C$33</c:f>
              <c:strCache>
                <c:ptCount val="1"/>
                <c:pt idx="0">
                  <c:v>139 Unknown randomly selected ginseng genes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MADS14!$A$34:$A$38</c:f>
              <c:strCache>
                <c:ptCount val="5"/>
                <c:pt idx="0">
                  <c:v>5.0-E02</c:v>
                </c:pt>
                <c:pt idx="1">
                  <c:v>1.0-E02</c:v>
                </c:pt>
                <c:pt idx="2">
                  <c:v>1.0-E03</c:v>
                </c:pt>
                <c:pt idx="3">
                  <c:v>1.0-E04</c:v>
                </c:pt>
                <c:pt idx="4">
                  <c:v>1.0-E05</c:v>
                </c:pt>
              </c:strCache>
              <c:extLst/>
            </c:strRef>
          </c:cat>
          <c:val>
            <c:numRef>
              <c:f>MADS14!$C$34:$C$38</c:f>
              <c:numCache>
                <c:formatCode>General</c:formatCode>
                <c:ptCount val="5"/>
                <c:pt idx="0">
                  <c:v>139</c:v>
                </c:pt>
                <c:pt idx="1">
                  <c:v>128</c:v>
                </c:pt>
                <c:pt idx="2">
                  <c:v>89</c:v>
                </c:pt>
                <c:pt idx="3">
                  <c:v>60</c:v>
                </c:pt>
                <c:pt idx="4">
                  <c:v>46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1-15A8-45F4-8CB0-96A6E54650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5927263"/>
        <c:axId val="2133351503"/>
      </c:lineChart>
      <c:catAx>
        <c:axId val="208592726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001" i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00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values</a:t>
                </a:r>
                <a:r>
                  <a:rPr lang="en-00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or network construction</a:t>
                </a:r>
                <a:endParaRPr lang="en-ZA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33351503"/>
        <c:crosses val="autoZero"/>
        <c:auto val="1"/>
        <c:lblAlgn val="ctr"/>
        <c:lblOffset val="100"/>
        <c:tickLblSkip val="1"/>
        <c:noMultiLvlLbl val="0"/>
      </c:catAx>
      <c:valAx>
        <c:axId val="213335150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00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nodes</a:t>
                </a:r>
                <a:endParaRPr lang="en-ZA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592726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MADS14!$B$44</c:f>
              <c:strCache>
                <c:ptCount val="1"/>
                <c:pt idx="0">
                  <c:v>139 PgMADS gene transcripts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MADS14!$A$45:$A$49</c:f>
              <c:strCache>
                <c:ptCount val="5"/>
                <c:pt idx="0">
                  <c:v>5.0-E02</c:v>
                </c:pt>
                <c:pt idx="1">
                  <c:v>1.0-E02</c:v>
                </c:pt>
                <c:pt idx="2">
                  <c:v>1.0-E03</c:v>
                </c:pt>
                <c:pt idx="3">
                  <c:v>1.0-E04</c:v>
                </c:pt>
                <c:pt idx="4">
                  <c:v>1.0-E05</c:v>
                </c:pt>
              </c:strCache>
              <c:extLst/>
            </c:strRef>
          </c:cat>
          <c:val>
            <c:numRef>
              <c:f>MADS14!$B$45:$B$49</c:f>
              <c:numCache>
                <c:formatCode>General</c:formatCode>
                <c:ptCount val="5"/>
                <c:pt idx="0">
                  <c:v>1222</c:v>
                </c:pt>
                <c:pt idx="1">
                  <c:v>786</c:v>
                </c:pt>
                <c:pt idx="2">
                  <c:v>505</c:v>
                </c:pt>
                <c:pt idx="3">
                  <c:v>389</c:v>
                </c:pt>
                <c:pt idx="4">
                  <c:v>326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0-501E-4874-A1B8-DB9652FB7230}"/>
            </c:ext>
          </c:extLst>
        </c:ser>
        <c:ser>
          <c:idx val="1"/>
          <c:order val="1"/>
          <c:tx>
            <c:strRef>
              <c:f>MADS14!$C$44</c:f>
              <c:strCache>
                <c:ptCount val="1"/>
                <c:pt idx="0">
                  <c:v>139 Unknown randomly selected ginseng genes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MADS14!$A$45:$A$49</c:f>
              <c:strCache>
                <c:ptCount val="5"/>
                <c:pt idx="0">
                  <c:v>5.0-E02</c:v>
                </c:pt>
                <c:pt idx="1">
                  <c:v>1.0-E02</c:v>
                </c:pt>
                <c:pt idx="2">
                  <c:v>1.0-E03</c:v>
                </c:pt>
                <c:pt idx="3">
                  <c:v>1.0-E04</c:v>
                </c:pt>
                <c:pt idx="4">
                  <c:v>1.0-E05</c:v>
                </c:pt>
              </c:strCache>
              <c:extLst/>
            </c:strRef>
          </c:cat>
          <c:val>
            <c:numRef>
              <c:f>MADS14!$C$45:$C$49</c:f>
              <c:numCache>
                <c:formatCode>General</c:formatCode>
                <c:ptCount val="5"/>
                <c:pt idx="0">
                  <c:v>1090</c:v>
                </c:pt>
                <c:pt idx="1">
                  <c:v>713</c:v>
                </c:pt>
                <c:pt idx="2">
                  <c:v>391</c:v>
                </c:pt>
                <c:pt idx="3">
                  <c:v>312</c:v>
                </c:pt>
                <c:pt idx="4">
                  <c:v>247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1-501E-4874-A1B8-DB9652FB72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3225327"/>
        <c:axId val="1743237535"/>
      </c:lineChart>
      <c:catAx>
        <c:axId val="213322532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00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values</a:t>
                </a:r>
                <a:r>
                  <a:rPr lang="en-00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or network construction</a:t>
                </a:r>
                <a:endParaRPr lang="en-ZA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43237535"/>
        <c:crosses val="autoZero"/>
        <c:auto val="1"/>
        <c:lblAlgn val="ctr"/>
        <c:lblOffset val="100"/>
        <c:tickLblSkip val="1"/>
        <c:noMultiLvlLbl val="0"/>
      </c:catAx>
      <c:valAx>
        <c:axId val="1743237535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00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edges</a:t>
                </a:r>
                <a:endParaRPr lang="en-ZA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3322532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3FD180-8DE6-4296-861B-09B1D38C5644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6A69CA-DE88-4F4B-8826-DCE482E902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61785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001" dirty="0"/>
              <a:t>*</a:t>
            </a:r>
            <a:endParaRPr lang="en-Z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6A69CA-DE88-4F4B-8826-DCE482E9028F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13321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095" y="1749795"/>
            <a:ext cx="6427074" cy="3722335"/>
          </a:xfrm>
        </p:spPr>
        <p:txBody>
          <a:bodyPr anchor="b"/>
          <a:lstStyle>
            <a:lvl1pPr algn="ctr">
              <a:defRPr sz="4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158" y="5615678"/>
            <a:ext cx="5670947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059" indent="0" algn="ctr">
              <a:buNone/>
              <a:defRPr sz="1654"/>
            </a:lvl2pPr>
            <a:lvl3pPr marL="756117" indent="0" algn="ctr">
              <a:buNone/>
              <a:defRPr sz="1488"/>
            </a:lvl3pPr>
            <a:lvl4pPr marL="1134176" indent="0" algn="ctr">
              <a:buNone/>
              <a:defRPr sz="1323"/>
            </a:lvl4pPr>
            <a:lvl5pPr marL="1512235" indent="0" algn="ctr">
              <a:buNone/>
              <a:defRPr sz="1323"/>
            </a:lvl5pPr>
            <a:lvl6pPr marL="1890293" indent="0" algn="ctr">
              <a:buNone/>
              <a:defRPr sz="1323"/>
            </a:lvl6pPr>
            <a:lvl7pPr marL="2268352" indent="0" algn="ctr">
              <a:buNone/>
              <a:defRPr sz="1323"/>
            </a:lvl7pPr>
            <a:lvl8pPr marL="2646411" indent="0" algn="ctr">
              <a:buNone/>
              <a:defRPr sz="1323"/>
            </a:lvl8pPr>
            <a:lvl9pPr marL="3024469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20156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93249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1029" y="569240"/>
            <a:ext cx="1630397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837" y="569240"/>
            <a:ext cx="4796676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76730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44026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899" y="2665532"/>
            <a:ext cx="6521589" cy="4447496"/>
          </a:xfrm>
        </p:spPr>
        <p:txBody>
          <a:bodyPr anchor="b"/>
          <a:lstStyle>
            <a:lvl1pPr>
              <a:defRPr sz="49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899" y="7155103"/>
            <a:ext cx="6521589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8059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117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417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235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29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35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641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44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92191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837" y="2846200"/>
            <a:ext cx="3213537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889" y="2846200"/>
            <a:ext cx="3213537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6860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569242"/>
            <a:ext cx="6521589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823" y="2620980"/>
            <a:ext cx="3198768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059" indent="0">
              <a:buNone/>
              <a:defRPr sz="1654" b="1"/>
            </a:lvl2pPr>
            <a:lvl3pPr marL="756117" indent="0">
              <a:buNone/>
              <a:defRPr sz="1488" b="1"/>
            </a:lvl3pPr>
            <a:lvl4pPr marL="1134176" indent="0">
              <a:buNone/>
              <a:defRPr sz="1323" b="1"/>
            </a:lvl4pPr>
            <a:lvl5pPr marL="1512235" indent="0">
              <a:buNone/>
              <a:defRPr sz="1323" b="1"/>
            </a:lvl5pPr>
            <a:lvl6pPr marL="1890293" indent="0">
              <a:buNone/>
              <a:defRPr sz="1323" b="1"/>
            </a:lvl6pPr>
            <a:lvl7pPr marL="2268352" indent="0">
              <a:buNone/>
              <a:defRPr sz="1323" b="1"/>
            </a:lvl7pPr>
            <a:lvl8pPr marL="2646411" indent="0">
              <a:buNone/>
              <a:defRPr sz="1323" b="1"/>
            </a:lvl8pPr>
            <a:lvl9pPr marL="3024469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823" y="3905482"/>
            <a:ext cx="3198768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890" y="2620980"/>
            <a:ext cx="3214522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059" indent="0">
              <a:buNone/>
              <a:defRPr sz="1654" b="1"/>
            </a:lvl2pPr>
            <a:lvl3pPr marL="756117" indent="0">
              <a:buNone/>
              <a:defRPr sz="1488" b="1"/>
            </a:lvl3pPr>
            <a:lvl4pPr marL="1134176" indent="0">
              <a:buNone/>
              <a:defRPr sz="1323" b="1"/>
            </a:lvl4pPr>
            <a:lvl5pPr marL="1512235" indent="0">
              <a:buNone/>
              <a:defRPr sz="1323" b="1"/>
            </a:lvl5pPr>
            <a:lvl6pPr marL="1890293" indent="0">
              <a:buNone/>
              <a:defRPr sz="1323" b="1"/>
            </a:lvl6pPr>
            <a:lvl7pPr marL="2268352" indent="0">
              <a:buNone/>
              <a:defRPr sz="1323" b="1"/>
            </a:lvl7pPr>
            <a:lvl8pPr marL="2646411" indent="0">
              <a:buNone/>
              <a:defRPr sz="1323" b="1"/>
            </a:lvl8pPr>
            <a:lvl9pPr marL="3024469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890" y="3905482"/>
            <a:ext cx="3214522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93301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92004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42292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788"/>
            <a:ext cx="2438704" cy="2494756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4522" y="1539425"/>
            <a:ext cx="3827889" cy="7598117"/>
          </a:xfrm>
        </p:spPr>
        <p:txBody>
          <a:bodyPr/>
          <a:lstStyle>
            <a:lvl1pPr>
              <a:defRPr sz="2646"/>
            </a:lvl1pPr>
            <a:lvl2pPr>
              <a:defRPr sz="2315"/>
            </a:lvl2pPr>
            <a:lvl3pPr>
              <a:defRPr sz="1985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7544"/>
            <a:ext cx="2438704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8059" indent="0">
              <a:buNone/>
              <a:defRPr sz="1158"/>
            </a:lvl2pPr>
            <a:lvl3pPr marL="756117" indent="0">
              <a:buNone/>
              <a:defRPr sz="992"/>
            </a:lvl3pPr>
            <a:lvl4pPr marL="1134176" indent="0">
              <a:buNone/>
              <a:defRPr sz="827"/>
            </a:lvl4pPr>
            <a:lvl5pPr marL="1512235" indent="0">
              <a:buNone/>
              <a:defRPr sz="827"/>
            </a:lvl5pPr>
            <a:lvl6pPr marL="1890293" indent="0">
              <a:buNone/>
              <a:defRPr sz="827"/>
            </a:lvl6pPr>
            <a:lvl7pPr marL="2268352" indent="0">
              <a:buNone/>
              <a:defRPr sz="827"/>
            </a:lvl7pPr>
            <a:lvl8pPr marL="2646411" indent="0">
              <a:buNone/>
              <a:defRPr sz="827"/>
            </a:lvl8pPr>
            <a:lvl9pPr marL="3024469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42165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822" y="712788"/>
            <a:ext cx="2438704" cy="2494756"/>
          </a:xfrm>
        </p:spPr>
        <p:txBody>
          <a:bodyPr anchor="b"/>
          <a:lstStyle>
            <a:lvl1pPr>
              <a:defRPr sz="264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4522" y="1539425"/>
            <a:ext cx="3827889" cy="7598117"/>
          </a:xfrm>
        </p:spPr>
        <p:txBody>
          <a:bodyPr anchor="t"/>
          <a:lstStyle>
            <a:lvl1pPr marL="0" indent="0">
              <a:buNone/>
              <a:defRPr sz="2646"/>
            </a:lvl1pPr>
            <a:lvl2pPr marL="378059" indent="0">
              <a:buNone/>
              <a:defRPr sz="2315"/>
            </a:lvl2pPr>
            <a:lvl3pPr marL="756117" indent="0">
              <a:buNone/>
              <a:defRPr sz="1985"/>
            </a:lvl3pPr>
            <a:lvl4pPr marL="1134176" indent="0">
              <a:buNone/>
              <a:defRPr sz="1654"/>
            </a:lvl4pPr>
            <a:lvl5pPr marL="1512235" indent="0">
              <a:buNone/>
              <a:defRPr sz="1654"/>
            </a:lvl5pPr>
            <a:lvl6pPr marL="1890293" indent="0">
              <a:buNone/>
              <a:defRPr sz="1654"/>
            </a:lvl6pPr>
            <a:lvl7pPr marL="2268352" indent="0">
              <a:buNone/>
              <a:defRPr sz="1654"/>
            </a:lvl7pPr>
            <a:lvl8pPr marL="2646411" indent="0">
              <a:buNone/>
              <a:defRPr sz="1654"/>
            </a:lvl8pPr>
            <a:lvl9pPr marL="3024469" indent="0">
              <a:buNone/>
              <a:defRPr sz="165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822" y="3207544"/>
            <a:ext cx="2438704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8059" indent="0">
              <a:buNone/>
              <a:defRPr sz="1158"/>
            </a:lvl2pPr>
            <a:lvl3pPr marL="756117" indent="0">
              <a:buNone/>
              <a:defRPr sz="992"/>
            </a:lvl3pPr>
            <a:lvl4pPr marL="1134176" indent="0">
              <a:buNone/>
              <a:defRPr sz="827"/>
            </a:lvl4pPr>
            <a:lvl5pPr marL="1512235" indent="0">
              <a:buNone/>
              <a:defRPr sz="827"/>
            </a:lvl5pPr>
            <a:lvl6pPr marL="1890293" indent="0">
              <a:buNone/>
              <a:defRPr sz="827"/>
            </a:lvl6pPr>
            <a:lvl7pPr marL="2268352" indent="0">
              <a:buNone/>
              <a:defRPr sz="827"/>
            </a:lvl7pPr>
            <a:lvl8pPr marL="2646411" indent="0">
              <a:buNone/>
              <a:defRPr sz="827"/>
            </a:lvl8pPr>
            <a:lvl9pPr marL="3024469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37558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837" y="569242"/>
            <a:ext cx="652158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837" y="2846200"/>
            <a:ext cx="6521589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837" y="9909729"/>
            <a:ext cx="170128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E694D3-D208-4974-BF22-E48BAE773DC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669" y="9909729"/>
            <a:ext cx="2551926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0142" y="9909729"/>
            <a:ext cx="170128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85F558-8381-47CB-B7E8-EB8214F72EF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35242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6117" rtl="0" eaLnBrk="1" latinLnBrk="0" hangingPunct="1">
        <a:lnSpc>
          <a:spcPct val="90000"/>
        </a:lnSpc>
        <a:spcBef>
          <a:spcPct val="0"/>
        </a:spcBef>
        <a:buNone/>
        <a:defRPr sz="36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29" indent="-189029" algn="l" defTabSz="756117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88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5147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205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1264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9323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7381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5440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3499" indent="-189029" algn="l" defTabSz="756117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8059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6117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4176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2235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90293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8352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6411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4469" algn="l" defTabSz="756117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chart" Target="../charts/chart4.xml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chart" Target="../charts/chart1.xml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7D1AD3EF-F62C-15E8-ACE8-E56D540285AE}"/>
              </a:ext>
            </a:extLst>
          </p:cNvPr>
          <p:cNvSpPr txBox="1"/>
          <p:nvPr/>
        </p:nvSpPr>
        <p:spPr>
          <a:xfrm>
            <a:off x="242278" y="8140593"/>
            <a:ext cx="7143260" cy="20277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. Co-expression network of the </a:t>
            </a:r>
            <a:r>
              <a:rPr lang="en-GB" sz="1000" b="1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gMADS</a:t>
            </a:r>
            <a:r>
              <a:rPr lang="en-GB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transcripts expressed in 14 tissues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(</a:t>
            </a:r>
            <a:r>
              <a:rPr lang="en-GB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The colorful balls indicate the co-expression network construction using 139 </a:t>
            </a:r>
            <a:r>
              <a:rPr lang="en-GB" sz="1000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gMADS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transcripts. The network was constructed at </a:t>
            </a:r>
            <a:r>
              <a:rPr lang="en-001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utoff of</a:t>
            </a:r>
            <a:r>
              <a:rPr lang="en-GB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001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GB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≤ 5.0</a:t>
            </a:r>
            <a:r>
              <a:rPr lang="en-001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x 10</a:t>
            </a:r>
            <a:r>
              <a:rPr lang="en-001" sz="1000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2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It consists of 139 gene nodes and 1,222 edges. (</a:t>
            </a:r>
            <a:r>
              <a:rPr lang="en-GB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Eleven clusters constituting the network. (</a:t>
            </a:r>
            <a:r>
              <a:rPr lang="en-GB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Tendency that </a:t>
            </a:r>
            <a:r>
              <a:rPr lang="en-GB" sz="1000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gMADS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transcripts form a network using the unknown randomly selected ginseng gene transcripts as a control: variation in number of nodes. (</a:t>
            </a:r>
            <a:r>
              <a:rPr lang="en-GB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Tendency that </a:t>
            </a:r>
            <a:r>
              <a:rPr lang="en-GB" sz="1000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gMADS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transcripts form a network using the unknown randomly selected ginseng gene transcripts as a control: variation in number of edges. (</a:t>
            </a:r>
            <a:r>
              <a:rPr lang="en-GB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Statistics of variation in</a:t>
            </a:r>
            <a:r>
              <a:rPr lang="en-001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he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number of nodes in the </a:t>
            </a:r>
            <a:r>
              <a:rPr lang="en-GB" sz="1000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gMADS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transcripts network. (</a:t>
            </a:r>
            <a:r>
              <a:rPr lang="en-GB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Statistics of variation in number of edges in the </a:t>
            </a:r>
            <a:r>
              <a:rPr lang="en-GB" sz="1000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gMADS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transcripts network. The 95 </a:t>
            </a:r>
            <a:r>
              <a:rPr lang="en-GB" sz="1000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gMADS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transcripts used for statistic</a:t>
            </a:r>
            <a:r>
              <a:rPr lang="en-001" sz="10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ls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alysis were randomly selected from the 139 </a:t>
            </a:r>
            <a:r>
              <a:rPr lang="en-GB" sz="1000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gMADS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 transcripts with 10 replications. The 95 unknown randomly selected ginseng transcripts</a:t>
            </a:r>
            <a:r>
              <a:rPr lang="en-001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elected from Dataset A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used as a control with 10 replications. Statistics of variation in number of nodes and edges were </a:t>
            </a:r>
            <a:r>
              <a:rPr lang="en-GB" sz="10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alyzed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001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sing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GB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test, with “*” at </a:t>
            </a:r>
            <a:r>
              <a:rPr lang="en-GB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≤ 0.05; “**” at </a:t>
            </a:r>
            <a:r>
              <a:rPr lang="en-GB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≤ 0.01. No mark is </a:t>
            </a:r>
            <a:r>
              <a:rPr lang="en-001" sz="100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</a:t>
            </a:r>
            <a:r>
              <a:rPr lang="en-GB" sz="100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on-significant 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ifference in</a:t>
            </a:r>
            <a:r>
              <a:rPr lang="en-001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number of nodes and edges. </a:t>
            </a:r>
            <a:r>
              <a:rPr lang="en-GB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rror bars, standard deviation.</a:t>
            </a:r>
            <a:endParaRPr lang="en-ZA" sz="10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B1481FBA-2226-CFAE-DA90-54B67CF5C5E3}"/>
              </a:ext>
            </a:extLst>
          </p:cNvPr>
          <p:cNvGrpSpPr/>
          <p:nvPr/>
        </p:nvGrpSpPr>
        <p:grpSpPr>
          <a:xfrm>
            <a:off x="828730" y="5342164"/>
            <a:ext cx="3321105" cy="312571"/>
            <a:chOff x="827412" y="5358956"/>
            <a:chExt cx="3321105" cy="312571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0AFE09F-7F54-1A13-E2B2-CE9079EA6CFC}"/>
                </a:ext>
              </a:extLst>
            </p:cNvPr>
            <p:cNvSpPr txBox="1"/>
            <p:nvPr/>
          </p:nvSpPr>
          <p:spPr>
            <a:xfrm>
              <a:off x="827412" y="5358956"/>
              <a:ext cx="367886" cy="2805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01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13D90E9-F3CD-72DE-851D-4FE7DF0907D4}"/>
                </a:ext>
              </a:extLst>
            </p:cNvPr>
            <p:cNvSpPr txBox="1"/>
            <p:nvPr/>
          </p:nvSpPr>
          <p:spPr>
            <a:xfrm>
              <a:off x="3780631" y="5394528"/>
              <a:ext cx="3678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01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5BC3EBF0-6418-3245-9B87-BBE898E787B6}"/>
              </a:ext>
            </a:extLst>
          </p:cNvPr>
          <p:cNvGrpSpPr/>
          <p:nvPr/>
        </p:nvGrpSpPr>
        <p:grpSpPr>
          <a:xfrm>
            <a:off x="726879" y="2955689"/>
            <a:ext cx="3577526" cy="284635"/>
            <a:chOff x="726879" y="2955689"/>
            <a:chExt cx="3577526" cy="284635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7141B91-629D-C4D7-CD8B-5ECC3DF039E0}"/>
                </a:ext>
              </a:extLst>
            </p:cNvPr>
            <p:cNvSpPr txBox="1"/>
            <p:nvPr/>
          </p:nvSpPr>
          <p:spPr>
            <a:xfrm>
              <a:off x="726879" y="2959799"/>
              <a:ext cx="323251" cy="2805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01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F33853C-C287-65BC-064C-F8AD4383A3A7}"/>
                </a:ext>
              </a:extLst>
            </p:cNvPr>
            <p:cNvSpPr txBox="1"/>
            <p:nvPr/>
          </p:nvSpPr>
          <p:spPr>
            <a:xfrm>
              <a:off x="3863346" y="2955689"/>
              <a:ext cx="441059" cy="2805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01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BF25B241-D213-6E28-DE2E-1B36970D31F5}"/>
              </a:ext>
            </a:extLst>
          </p:cNvPr>
          <p:cNvGrpSpPr/>
          <p:nvPr/>
        </p:nvGrpSpPr>
        <p:grpSpPr>
          <a:xfrm>
            <a:off x="688873" y="457538"/>
            <a:ext cx="5940000" cy="2471974"/>
            <a:chOff x="983862" y="470474"/>
            <a:chExt cx="5940000" cy="2286924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012670DB-E6D6-7230-4747-F3ED238B6C65}"/>
                </a:ext>
              </a:extLst>
            </p:cNvPr>
            <p:cNvGrpSpPr/>
            <p:nvPr/>
          </p:nvGrpSpPr>
          <p:grpSpPr>
            <a:xfrm>
              <a:off x="1303433" y="694469"/>
              <a:ext cx="5620429" cy="2062929"/>
              <a:chOff x="1100655" y="2889029"/>
              <a:chExt cx="5404493" cy="2062929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D4B7E928-FF81-3325-E1E8-4BBBC4E979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028" t="14216" r="23421" b="8586"/>
              <a:stretch/>
            </p:blipFill>
            <p:spPr bwMode="auto">
              <a:xfrm>
                <a:off x="1100655" y="2889029"/>
                <a:ext cx="1852568" cy="1964999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544ED322-05F7-3F04-46EA-D35A3951521D}"/>
                  </a:ext>
                </a:extLst>
              </p:cNvPr>
              <p:cNvGrpSpPr/>
              <p:nvPr/>
            </p:nvGrpSpPr>
            <p:grpSpPr>
              <a:xfrm>
                <a:off x="3085148" y="2971958"/>
                <a:ext cx="3420000" cy="1980000"/>
                <a:chOff x="3191828" y="3002438"/>
                <a:chExt cx="3191666" cy="1872298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4535726A-76DA-B996-D20B-59C52D9F0CE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486" t="17885" r="45491" b="61631"/>
                <a:stretch/>
              </p:blipFill>
              <p:spPr bwMode="auto">
                <a:xfrm>
                  <a:off x="3191828" y="3076099"/>
                  <a:ext cx="719455" cy="8534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68CC67AD-33F1-87F8-F946-129D838303F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497" t="35159" r="48150" b="42370"/>
                <a:stretch/>
              </p:blipFill>
              <p:spPr bwMode="auto">
                <a:xfrm>
                  <a:off x="3937833" y="3104671"/>
                  <a:ext cx="719455" cy="8604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5FD63BCF-47EA-305C-207A-EAD22422FF1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059" t="34548" r="35652" b="45274"/>
                <a:stretch/>
              </p:blipFill>
              <p:spPr bwMode="auto">
                <a:xfrm>
                  <a:off x="4683839" y="3076099"/>
                  <a:ext cx="719455" cy="8261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CE6E2E2D-8D90-5FD9-AB57-AF841E574F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157" t="32408" r="46820" b="34573"/>
                <a:stretch/>
              </p:blipFill>
              <p:spPr bwMode="auto">
                <a:xfrm>
                  <a:off x="5435283" y="3002439"/>
                  <a:ext cx="470535" cy="8997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A322CD6B-3480-6D04-7096-E97044F81E7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058" t="33478" r="21028" b="49554"/>
                <a:stretch/>
              </p:blipFill>
              <p:spPr bwMode="auto">
                <a:xfrm rot="5400000">
                  <a:off x="5711664" y="3230403"/>
                  <a:ext cx="899795" cy="4438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22A0E019-C4DE-4FB7-7B7A-6812CFE323A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5174" t="19108" r="31664" b="47414"/>
                <a:stretch/>
              </p:blipFill>
              <p:spPr bwMode="auto">
                <a:xfrm>
                  <a:off x="3296921" y="3974941"/>
                  <a:ext cx="406400" cy="8997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CFD7AA37-50A8-003E-4D45-096CD8CFF33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9162" t="19720" r="21028" b="57045"/>
                <a:stretch/>
              </p:blipFill>
              <p:spPr bwMode="auto">
                <a:xfrm>
                  <a:off x="3781028" y="4013677"/>
                  <a:ext cx="755650" cy="7708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1DEBB7A8-E4A8-190B-C775-47107E844D5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729" t="16509" r="61578" b="69274"/>
                <a:stretch/>
              </p:blipFill>
              <p:spPr bwMode="auto">
                <a:xfrm rot="16200000">
                  <a:off x="4501753" y="4044155"/>
                  <a:ext cx="719455" cy="64960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372420C3-D859-13AE-31EF-AE459D45B4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110" t="23389" r="40705" b="53987"/>
                <a:stretch/>
              </p:blipFill>
              <p:spPr bwMode="auto">
                <a:xfrm>
                  <a:off x="5301495" y="3902233"/>
                  <a:ext cx="236855" cy="8997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3BF5E5F6-A696-1A2A-75B1-3A57A0F5B4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469" t="52586" r="41369" b="42344"/>
                <a:stretch/>
              </p:blipFill>
              <p:spPr bwMode="auto">
                <a:xfrm rot="5400000">
                  <a:off x="5379879" y="4225766"/>
                  <a:ext cx="754380" cy="2527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3485978D-A847-C383-3043-3230357FD92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098" t="35923" r="35121" b="42064"/>
                <a:stretch/>
              </p:blipFill>
              <p:spPr bwMode="auto">
                <a:xfrm>
                  <a:off x="6065359" y="3974941"/>
                  <a:ext cx="318135" cy="8997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</p:grp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179FBA7-5C15-28D8-3EC0-4D6A55D8A89E}"/>
                </a:ext>
              </a:extLst>
            </p:cNvPr>
            <p:cNvSpPr txBox="1"/>
            <p:nvPr/>
          </p:nvSpPr>
          <p:spPr>
            <a:xfrm>
              <a:off x="983862" y="470474"/>
              <a:ext cx="270246" cy="2562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01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35552E5-3A6C-962E-22AD-69426A46F98B}"/>
                </a:ext>
              </a:extLst>
            </p:cNvPr>
            <p:cNvSpPr txBox="1"/>
            <p:nvPr/>
          </p:nvSpPr>
          <p:spPr>
            <a:xfrm>
              <a:off x="3709655" y="477410"/>
              <a:ext cx="382294" cy="2562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01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2A603905-32C3-16FB-AD08-24E16BDDF5D8}"/>
              </a:ext>
            </a:extLst>
          </p:cNvPr>
          <p:cNvGrpSpPr/>
          <p:nvPr/>
        </p:nvGrpSpPr>
        <p:grpSpPr>
          <a:xfrm>
            <a:off x="694881" y="3138650"/>
            <a:ext cx="6003923" cy="4767316"/>
            <a:chOff x="694881" y="3138650"/>
            <a:chExt cx="6003923" cy="4767316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1AF005DB-B32B-8A2D-C005-E6C72C50BBD3}"/>
                </a:ext>
              </a:extLst>
            </p:cNvPr>
            <p:cNvGrpSpPr/>
            <p:nvPr/>
          </p:nvGrpSpPr>
          <p:grpSpPr>
            <a:xfrm>
              <a:off x="758804" y="5385966"/>
              <a:ext cx="5940000" cy="2520000"/>
              <a:chOff x="688873" y="5651807"/>
              <a:chExt cx="5940000" cy="2520000"/>
            </a:xfrm>
          </p:grpSpPr>
          <p:graphicFrame>
            <p:nvGraphicFramePr>
              <p:cNvPr id="14" name="Chart 13">
                <a:extLst>
                  <a:ext uri="{FF2B5EF4-FFF2-40B4-BE49-F238E27FC236}">
                    <a16:creationId xmlns:a16="http://schemas.microsoft.com/office/drawing/2014/main" id="{D8B99F76-7988-1E9D-9656-78B933B53F3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381407"/>
                  </p:ext>
                </p:extLst>
              </p:nvPr>
            </p:nvGraphicFramePr>
            <p:xfrm>
              <a:off x="688873" y="5651807"/>
              <a:ext cx="2880475" cy="252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  <p:graphicFrame>
            <p:nvGraphicFramePr>
              <p:cNvPr id="15" name="Chart 14">
                <a:extLst>
                  <a:ext uri="{FF2B5EF4-FFF2-40B4-BE49-F238E27FC236}">
                    <a16:creationId xmlns:a16="http://schemas.microsoft.com/office/drawing/2014/main" id="{324E3AD7-F1CD-BE7E-1D43-B6869BC02B6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54410067"/>
                  </p:ext>
                </p:extLst>
              </p:nvPr>
            </p:nvGraphicFramePr>
            <p:xfrm>
              <a:off x="3748873" y="5651807"/>
              <a:ext cx="2880000" cy="252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6"/>
              </a:graphicData>
            </a:graphic>
          </p:graphicFrame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7F97758E-9E49-95C1-1919-9467F1BDA3E2}"/>
                </a:ext>
              </a:extLst>
            </p:cNvPr>
            <p:cNvGrpSpPr/>
            <p:nvPr/>
          </p:nvGrpSpPr>
          <p:grpSpPr>
            <a:xfrm>
              <a:off x="694881" y="3138650"/>
              <a:ext cx="5880839" cy="2374235"/>
              <a:chOff x="694881" y="3138650"/>
              <a:chExt cx="5880839" cy="2374235"/>
            </a:xfrm>
          </p:grpSpPr>
          <p:graphicFrame>
            <p:nvGraphicFramePr>
              <p:cNvPr id="31" name="Chart 30">
                <a:extLst>
                  <a:ext uri="{FF2B5EF4-FFF2-40B4-BE49-F238E27FC236}">
                    <a16:creationId xmlns:a16="http://schemas.microsoft.com/office/drawing/2014/main" id="{D4982E8F-F33F-2593-53D8-C6878BDA08E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54946765"/>
                  </p:ext>
                </p:extLst>
              </p:nvPr>
            </p:nvGraphicFramePr>
            <p:xfrm>
              <a:off x="694881" y="3172885"/>
              <a:ext cx="2880000" cy="234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7"/>
              </a:graphicData>
            </a:graphic>
          </p:graphicFrame>
          <p:graphicFrame>
            <p:nvGraphicFramePr>
              <p:cNvPr id="32" name="Chart 31">
                <a:extLst>
                  <a:ext uri="{FF2B5EF4-FFF2-40B4-BE49-F238E27FC236}">
                    <a16:creationId xmlns:a16="http://schemas.microsoft.com/office/drawing/2014/main" id="{78C42F04-9322-995D-290E-1C05D53648F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72800708"/>
                  </p:ext>
                </p:extLst>
              </p:nvPr>
            </p:nvGraphicFramePr>
            <p:xfrm>
              <a:off x="3695720" y="3138650"/>
              <a:ext cx="2880000" cy="234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8"/>
              </a:graphicData>
            </a:graphic>
          </p:graphicFrame>
        </p:grp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B025DC44-ED01-9C03-73EA-849911890F06}"/>
              </a:ext>
            </a:extLst>
          </p:cNvPr>
          <p:cNvSpPr txBox="1"/>
          <p:nvPr/>
        </p:nvSpPr>
        <p:spPr>
          <a:xfrm>
            <a:off x="2277706" y="6331742"/>
            <a:ext cx="3385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1000" b="1" dirty="0"/>
              <a:t>**</a:t>
            </a:r>
            <a:endParaRPr lang="en-ZA" sz="1000" b="1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EAC46F7-E3DD-2FA7-9068-00676F82E267}"/>
              </a:ext>
            </a:extLst>
          </p:cNvPr>
          <p:cNvSpPr txBox="1"/>
          <p:nvPr/>
        </p:nvSpPr>
        <p:spPr>
          <a:xfrm>
            <a:off x="3126442" y="6563230"/>
            <a:ext cx="414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1000" b="1" dirty="0"/>
              <a:t>* *</a:t>
            </a:r>
            <a:endParaRPr lang="en-ZA" sz="1000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E4E9ED9-BD8E-DBFD-42B3-A87D777A36AA}"/>
              </a:ext>
            </a:extLst>
          </p:cNvPr>
          <p:cNvSpPr txBox="1"/>
          <p:nvPr/>
        </p:nvSpPr>
        <p:spPr>
          <a:xfrm>
            <a:off x="1856727" y="6124407"/>
            <a:ext cx="414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1000" b="1" dirty="0"/>
              <a:t>* *</a:t>
            </a:r>
            <a:endParaRPr lang="en-ZA" sz="1000" b="1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58D6F03-7E2E-9477-23AC-3D5156423601}"/>
              </a:ext>
            </a:extLst>
          </p:cNvPr>
          <p:cNvSpPr txBox="1"/>
          <p:nvPr/>
        </p:nvSpPr>
        <p:spPr>
          <a:xfrm>
            <a:off x="2650758" y="6499160"/>
            <a:ext cx="4168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001" sz="1000" b="1" dirty="0"/>
              <a:t>* *</a:t>
            </a:r>
            <a:endParaRPr lang="en-ZA" sz="1000" b="1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06EDFB1-A2F2-C170-A48C-12025E29A662}"/>
              </a:ext>
            </a:extLst>
          </p:cNvPr>
          <p:cNvSpPr txBox="1"/>
          <p:nvPr/>
        </p:nvSpPr>
        <p:spPr>
          <a:xfrm>
            <a:off x="1485832" y="6060310"/>
            <a:ext cx="2464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1000" b="1" dirty="0"/>
              <a:t>*</a:t>
            </a:r>
            <a:endParaRPr lang="en-ZA" sz="1000" b="1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FF5C44A-BCE9-FB43-CBA6-A8DA1F9C9CB4}"/>
              </a:ext>
            </a:extLst>
          </p:cNvPr>
          <p:cNvSpPr txBox="1"/>
          <p:nvPr/>
        </p:nvSpPr>
        <p:spPr>
          <a:xfrm>
            <a:off x="4481496" y="6051887"/>
            <a:ext cx="361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1000" b="1" dirty="0"/>
              <a:t>* *</a:t>
            </a:r>
            <a:endParaRPr lang="en-ZA" sz="1000" b="1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613F1C9-9CF4-38B5-009E-811280D19FEA}"/>
              </a:ext>
            </a:extLst>
          </p:cNvPr>
          <p:cNvSpPr txBox="1"/>
          <p:nvPr/>
        </p:nvSpPr>
        <p:spPr>
          <a:xfrm>
            <a:off x="4909977" y="6455508"/>
            <a:ext cx="451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800" b="1" dirty="0"/>
              <a:t> </a:t>
            </a:r>
            <a:r>
              <a:rPr lang="en-001" sz="1000" b="1" dirty="0"/>
              <a:t>* *</a:t>
            </a:r>
            <a:endParaRPr lang="en-ZA" sz="1000" b="1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4564504B-CE8E-8F79-904B-1FBB4704187F}"/>
              </a:ext>
            </a:extLst>
          </p:cNvPr>
          <p:cNvSpPr txBox="1"/>
          <p:nvPr/>
        </p:nvSpPr>
        <p:spPr>
          <a:xfrm>
            <a:off x="5250353" y="6702070"/>
            <a:ext cx="5396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800" b="1" dirty="0"/>
              <a:t>   </a:t>
            </a:r>
            <a:r>
              <a:rPr lang="en-001" sz="1000" b="1" dirty="0"/>
              <a:t> * *</a:t>
            </a:r>
            <a:endParaRPr lang="en-ZA" sz="1000" b="1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9BB092B6-A69D-3A16-F019-41DC4870881F}"/>
              </a:ext>
            </a:extLst>
          </p:cNvPr>
          <p:cNvSpPr txBox="1"/>
          <p:nvPr/>
        </p:nvSpPr>
        <p:spPr>
          <a:xfrm>
            <a:off x="5789998" y="6820147"/>
            <a:ext cx="272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1000" b="1" dirty="0"/>
              <a:t>*</a:t>
            </a:r>
            <a:endParaRPr lang="en-ZA" sz="1000" b="1" dirty="0"/>
          </a:p>
        </p:txBody>
      </p:sp>
    </p:spTree>
    <p:extLst>
      <p:ext uri="{BB962C8B-B14F-4D97-AF65-F5344CB8AC3E}">
        <p14:creationId xmlns:p14="http://schemas.microsoft.com/office/powerpoint/2010/main" val="2537571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9</TotalTime>
  <Words>304</Words>
  <Application>Microsoft Office PowerPoint</Application>
  <PresentationFormat>Custom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leho Lephoto</dc:creator>
  <cp:lastModifiedBy>Katleho Lephoto</cp:lastModifiedBy>
  <cp:revision>79</cp:revision>
  <dcterms:created xsi:type="dcterms:W3CDTF">2024-04-17T13:46:49Z</dcterms:created>
  <dcterms:modified xsi:type="dcterms:W3CDTF">2024-12-20T21:39:27Z</dcterms:modified>
</cp:coreProperties>
</file>